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6"/>
  </p:notesMasterIdLst>
  <p:handoutMasterIdLst>
    <p:handoutMasterId r:id="rId17"/>
  </p:handoutMasterIdLst>
  <p:sldIdLst>
    <p:sldId id="256" r:id="rId2"/>
    <p:sldId id="259" r:id="rId3"/>
    <p:sldId id="258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-636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>
              <a:ea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>
                <a:cs typeface="Times New Roman" panose="02020603050405020304" charset="0"/>
              </a:rPr>
              <a:t>2020/9/29</a:t>
            </a:fld>
            <a:endParaRPr lang="zh-CN" altLang="en-US">
              <a:cs typeface="Times New Roman" panose="0202060305040502030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>
              <a:ea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>
                <a:cs typeface="Times New Roman" panose="02020603050405020304" charset="0"/>
              </a:rPr>
              <a:t>‹#›</a:t>
            </a:fld>
            <a:endParaRPr lang="zh-CN" altLang="en-US">
              <a:cs typeface="Times New Roman" panose="0202060305040502030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451046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ea typeface="Times New Roman" panose="02020603050405020304" charset="0"/>
                <a:cs typeface="Times New Roman" panose="02020603050405020304" charset="0"/>
              </a:defRPr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ea typeface="Times New Roman" panose="02020603050405020304" charset="0"/>
                <a:cs typeface="Times New Roman" panose="02020603050405020304" charset="0"/>
              </a:defRPr>
            </a:lvl1pPr>
          </a:lstStyle>
          <a:p>
            <a:fld id="{D2A48B96-639E-45A3-A0BA-2464DFDB1FAA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ea typeface="Times New Roman" panose="02020603050405020304" charset="0"/>
                <a:cs typeface="Times New Roman" panose="02020603050405020304" charset="0"/>
              </a:defRPr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>
                <a:ea typeface="Times New Roman" panose="02020603050405020304" charset="0"/>
                <a:cs typeface="Times New Roman" panose="02020603050405020304" charset="0"/>
              </a:defRPr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17934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Times New Roman" panose="02020603050405020304" charset="0"/>
        <a:cs typeface="Times New Roman" panose="02020603050405020304" charset="0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Times New Roman" panose="02020603050405020304" charset="0"/>
        <a:cs typeface="Times New Roman" panose="02020603050405020304" charset="0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Times New Roman" panose="02020603050405020304" charset="0"/>
        <a:cs typeface="Times New Roman" panose="02020603050405020304" charset="0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Times New Roman" panose="02020603050405020304" charset="0"/>
        <a:cs typeface="Times New Roman" panose="02020603050405020304" charset="0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Times New Roman" panose="02020603050405020304" charset="0"/>
        <a:cs typeface="Times New Roman" panose="02020603050405020304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 hasCustomPrompt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 hasCustomPrompt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 hasCustomPrompt="1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 hasCustomPrompt="1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 hasCustomPrompt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 hasCustomPrompt="1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defRPr>
            </a:lvl1pPr>
          </a:lstStyle>
          <a:p>
            <a:fld id="{62820748-22F2-4E48-9083-C2C0772F5093}" type="datetimeFigureOut">
              <a:rPr lang="zh-CN" altLang="en-US" smtClean="0"/>
              <a:t>2020/9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Times New Roman" panose="02020603050405020304" charset="0"/>
                <a:ea typeface="Times New Roman" panose="02020603050405020304" charset="0"/>
                <a:cs typeface="Times New Roman" panose="02020603050405020304" charset="0"/>
              </a:defRPr>
            </a:lvl1pPr>
          </a:lstStyle>
          <a:p>
            <a:fld id="{F83528D0-0A09-4497-97FC-C975367ACD9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Times New Roman" panose="02020603050405020304" charset="0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Times New Roman" panose="02020603050405020304" charset="0"/>
          <a:ea typeface="Times New Roman" panose="02020603050405020304" charset="0"/>
          <a:cs typeface="Times New Roman" panose="02020603050405020304" charset="0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Times New Roman" panose="02020603050405020304" charset="0"/>
          <a:ea typeface="Times New Roman" panose="02020603050405020304" charset="0"/>
          <a:cs typeface="Times New Roman" panose="02020603050405020304" charset="0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Times New Roman" panose="02020603050405020304" charset="0"/>
          <a:ea typeface="Times New Roman" panose="02020603050405020304" charset="0"/>
          <a:cs typeface="Times New Roman" panose="02020603050405020304" charset="0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Times New Roman" panose="02020603050405020304" charset="0"/>
          <a:ea typeface="Times New Roman" panose="02020603050405020304" charset="0"/>
          <a:cs typeface="Times New Roman" panose="02020603050405020304" charset="0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Times New Roman" panose="02020603050405020304" charset="0"/>
          <a:ea typeface="Times New Roman" panose="02020603050405020304" charset="0"/>
          <a:cs typeface="Times New Roman" panose="02020603050405020304" charset="0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图片 1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455" y="1886410"/>
            <a:ext cx="9964100" cy="4615915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030245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4B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3474928" y="139257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3959551" y="1518165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4510973" y="1518164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5088045" y="1518163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 rot="19800086">
            <a:off x="2766674" y="139257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2" name="标题 1"/>
          <p:cNvSpPr txBox="1"/>
          <p:nvPr/>
        </p:nvSpPr>
        <p:spPr>
          <a:xfrm>
            <a:off x="4841225" y="718591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 fontScale="97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5465250" y="1251751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" name="矩形 2"/>
          <p:cNvSpPr/>
          <p:nvPr/>
        </p:nvSpPr>
        <p:spPr>
          <a:xfrm>
            <a:off x="2852963" y="4146107"/>
            <a:ext cx="6078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>
                <a:latin typeface="Times New Roman" panose="02020603050405020304" charset="0"/>
                <a:cs typeface="Arial" panose="020B0604020202020204" pitchFamily="34" charset="0"/>
              </a:rPr>
              <a:t>Bax</a:t>
            </a:r>
            <a:endParaRPr lang="zh-CN" altLang="en-US" b="1"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706880" y="48895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4B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>
                <a:cs typeface="Times New Roman" panose="02020603050405020304" charset="0"/>
              </a:rPr>
              <a:t>Bax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7372985" y="4145915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21 kDa</a:t>
            </a: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6A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673414" y="1303800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SC99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873624" y="1303801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PBS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517" y="2065464"/>
            <a:ext cx="9836458" cy="4568118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3345088" y="3892107"/>
            <a:ext cx="9829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p-JAK2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6452235" y="3891915"/>
            <a:ext cx="9893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130 kDa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1610360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6A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p-JAK2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09"/>
          <a:stretch>
            <a:fillRect/>
          </a:stretch>
        </p:blipFill>
        <p:spPr>
          <a:xfrm>
            <a:off x="169545" y="1795145"/>
            <a:ext cx="10616565" cy="4996180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6A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673414" y="1303800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SC99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873624" y="1303801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PBS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345088" y="4130232"/>
            <a:ext cx="7670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JAK2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6690360" y="4130040"/>
            <a:ext cx="9893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130 kDa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1562735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6A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JAK2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1915592"/>
            <a:ext cx="9215022" cy="4844754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6A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673414" y="1303800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SC99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873624" y="1303801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PBS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424463" y="4209607"/>
            <a:ext cx="108839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p-STAT3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6531610" y="4209415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88 kDa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1628140" y="49530"/>
            <a:ext cx="104457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6A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zh-CN" altLang="en-US" b="1">
                <a:cs typeface="Times New Roman" panose="02020603050405020304" charset="0"/>
                <a:sym typeface="+mn-ea"/>
              </a:rPr>
              <a:t>p-STAT3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129" y="1826832"/>
            <a:ext cx="9883618" cy="4396414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6A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673414" y="1303800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SC99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4077810" y="1303800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PBS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3360963" y="3622232"/>
            <a:ext cx="85979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zh-CN" altLang="en-US" b="1">
                <a:cs typeface="Times New Roman" panose="02020603050405020304" charset="0"/>
                <a:sym typeface="+mn-ea"/>
              </a:rPr>
              <a:t>STAT3</a:t>
            </a:r>
            <a:endParaRPr lang="en-US" altLang="zh-CN" b="1" smtClean="0">
              <a:latin typeface="Times New Roman" panose="0202060305040502030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6579235" y="3637915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88 kDa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1746250" y="49530"/>
            <a:ext cx="104457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6A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zh-CN" altLang="en-US" b="1">
                <a:cs typeface="Times New Roman" panose="02020603050405020304" charset="0"/>
                <a:sym typeface="+mn-ea"/>
              </a:rPr>
              <a:t>STAT3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004" y="2032986"/>
            <a:ext cx="10253666" cy="4367813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</a:t>
            </a:r>
            <a:r>
              <a:rPr lang="en-US" sz="2800" smtClean="0">
                <a:latin typeface="Times New Roman" panose="02020603050405020304" charset="0"/>
                <a:cs typeface="Arial" panose="020B0604020202020204" pitchFamily="34" charset="0"/>
              </a:rPr>
              <a:t>6A</a:t>
            </a:r>
            <a:endParaRPr 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974421" y="1380663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SC99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4203669" y="1380663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+PBS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3662588" y="3590482"/>
            <a:ext cx="86233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l-GR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actin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6960235" y="3590290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42 kDa</a:t>
            </a:r>
          </a:p>
        </p:txBody>
      </p:sp>
      <p:sp>
        <p:nvSpPr>
          <p:cNvPr id="8" name="文本框 7"/>
          <p:cNvSpPr txBox="1"/>
          <p:nvPr/>
        </p:nvSpPr>
        <p:spPr>
          <a:xfrm>
            <a:off x="1746250" y="49530"/>
            <a:ext cx="10445750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6A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l-GR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actin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441" y="1762225"/>
            <a:ext cx="9654464" cy="5095775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030245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4B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3474928" y="139257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3959551" y="1518165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4510973" y="1518164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5088045" y="1518163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 rot="19800086">
            <a:off x="2766674" y="139257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2" name="标题 1"/>
          <p:cNvSpPr txBox="1"/>
          <p:nvPr/>
        </p:nvSpPr>
        <p:spPr>
          <a:xfrm>
            <a:off x="4841225" y="718591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5465250" y="1251751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>
            <a:off x="1706880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4B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Bcl-2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  <p:sp>
        <p:nvSpPr>
          <p:cNvPr id="5" name="矩形 4"/>
          <p:cNvSpPr/>
          <p:nvPr/>
        </p:nvSpPr>
        <p:spPr>
          <a:xfrm>
            <a:off x="2852963" y="3876232"/>
            <a:ext cx="7416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Bcl-2</a:t>
            </a:r>
            <a:endParaRPr lang="zh-CN" altLang="en-US" b="1">
              <a:cs typeface="Times New Roman" panose="0202060305040502030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7372985" y="3876040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26 kDa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4562" y="1722408"/>
            <a:ext cx="10603653" cy="5135592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030245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4B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265041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4749664" y="1429388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5301086" y="1429387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5878158" y="142938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556787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>
            <a:off x="5631338" y="629814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255363" y="1162974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>
            <a:off x="1579245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4B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l-GR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actin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  <p:sp>
        <p:nvSpPr>
          <p:cNvPr id="3" name="矩形 2"/>
          <p:cNvSpPr/>
          <p:nvPr/>
        </p:nvSpPr>
        <p:spPr>
          <a:xfrm>
            <a:off x="3472088" y="4130232"/>
            <a:ext cx="9321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actin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7992110" y="4130040"/>
            <a:ext cx="883575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42 </a:t>
            </a:r>
            <a:r>
              <a:rPr lang="en-US" b="1" smtClean="0">
                <a:ea typeface="Times New Roman" panose="02020603050405020304" charset="0"/>
                <a:cs typeface="Times New Roman" panose="02020603050405020304" charset="0"/>
              </a:rPr>
              <a:t>kDa</a:t>
            </a:r>
            <a:endParaRPr lang="en-US" b="1">
              <a:ea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868" y="1774143"/>
            <a:ext cx="9929750" cy="5008397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5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265041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4749664" y="1429388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5301086" y="1429387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5878158" y="142938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556787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>
            <a:off x="5631338" y="629814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255363" y="1162974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/>
        </p:nvSpPr>
        <p:spPr>
          <a:xfrm>
            <a:off x="1405255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5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p-JAK2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  <p:sp>
        <p:nvSpPr>
          <p:cNvPr id="3" name="矩形 2"/>
          <p:cNvSpPr/>
          <p:nvPr/>
        </p:nvSpPr>
        <p:spPr>
          <a:xfrm>
            <a:off x="3345088" y="3939732"/>
            <a:ext cx="9829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p-JAK2</a:t>
            </a:r>
          </a:p>
        </p:txBody>
      </p:sp>
      <p:sp>
        <p:nvSpPr>
          <p:cNvPr id="13" name="文本框 12"/>
          <p:cNvSpPr txBox="1"/>
          <p:nvPr/>
        </p:nvSpPr>
        <p:spPr>
          <a:xfrm>
            <a:off x="7865110" y="3939540"/>
            <a:ext cx="998991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130 </a:t>
            </a:r>
            <a:r>
              <a:rPr lang="en-US" b="1" smtClean="0">
                <a:ea typeface="Times New Roman" panose="02020603050405020304" charset="0"/>
                <a:cs typeface="Times New Roman" panose="02020603050405020304" charset="0"/>
              </a:rPr>
              <a:t>kDa</a:t>
            </a:r>
            <a:endParaRPr lang="en-US" b="1">
              <a:ea typeface="Times New Roman" panose="02020603050405020304" charset="0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0652" y="1915507"/>
            <a:ext cx="10129421" cy="4747303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5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265041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4749664" y="1429388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5301086" y="1429387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5878158" y="142938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556787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>
            <a:off x="5631338" y="629814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255363" y="1162974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3367948" y="4105467"/>
            <a:ext cx="7670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JAK2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7944485" y="4130040"/>
            <a:ext cx="998991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130 </a:t>
            </a:r>
            <a:r>
              <a:rPr lang="en-US" b="1" smtClean="0">
                <a:ea typeface="Times New Roman" panose="02020603050405020304" charset="0"/>
                <a:cs typeface="Times New Roman" panose="02020603050405020304" charset="0"/>
              </a:rPr>
              <a:t>kDa</a:t>
            </a:r>
            <a:endParaRPr lang="en-US" b="1">
              <a:ea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386840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5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JAK2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2268" y="1914469"/>
            <a:ext cx="9906701" cy="4858872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5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265041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4749664" y="1429388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5301086" y="1429387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5878158" y="142938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556787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>
            <a:off x="5631338" y="629814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255363" y="1162974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3408588" y="4161982"/>
            <a:ext cx="9321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actin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7928610" y="4161790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42 kDa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1437640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5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l-GR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actin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1830" y="1787859"/>
            <a:ext cx="9618229" cy="4799373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5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265041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4749664" y="1429388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5301086" y="1429387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5878158" y="142938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556787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>
            <a:off x="5631338" y="629814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255363" y="1162974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3535588" y="3939732"/>
            <a:ext cx="108839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p-STAT3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8055610" y="3939540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88 kDa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1531620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5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p-STAT3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2315" y="1869783"/>
            <a:ext cx="9761405" cy="4815102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5 </a:t>
            </a:r>
            <a:endParaRPr lang="zh-CN" alt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265041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4749664" y="1429388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5301086" y="1429387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5878158" y="142938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556787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>
            <a:off x="5631338" y="629814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255363" y="1162974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8087360" y="4130040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88 kDa</a:t>
            </a:r>
          </a:p>
        </p:txBody>
      </p:sp>
      <p:sp>
        <p:nvSpPr>
          <p:cNvPr id="15" name="矩形 14"/>
          <p:cNvSpPr/>
          <p:nvPr/>
        </p:nvSpPr>
        <p:spPr>
          <a:xfrm>
            <a:off x="3535588" y="4130232"/>
            <a:ext cx="87249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STAT3</a:t>
            </a:r>
          </a:p>
        </p:txBody>
      </p:sp>
      <p:sp>
        <p:nvSpPr>
          <p:cNvPr id="16" name="文本框 15"/>
          <p:cNvSpPr txBox="1"/>
          <p:nvPr/>
        </p:nvSpPr>
        <p:spPr>
          <a:xfrm>
            <a:off x="1472565" y="48895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5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STAT3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7412" y="1783553"/>
            <a:ext cx="9855901" cy="4839188"/>
          </a:xfrm>
          <a:prstGeom prst="rect">
            <a:avLst/>
          </a:prstGeom>
        </p:spPr>
      </p:pic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-191" y="23"/>
            <a:ext cx="3119021" cy="466740"/>
          </a:xfrm>
        </p:spPr>
        <p:txBody>
          <a:bodyPr>
            <a:normAutofit fontScale="90000"/>
          </a:bodyPr>
          <a:lstStyle/>
          <a:p>
            <a:pPr algn="l"/>
            <a:r>
              <a:rPr lang="en-US" altLang="zh-CN" sz="2800" smtClean="0">
                <a:latin typeface="Times New Roman" panose="02020603050405020304" charset="0"/>
                <a:cs typeface="Arial" panose="020B0604020202020204" pitchFamily="34" charset="0"/>
              </a:rPr>
              <a:t>Figure </a:t>
            </a:r>
            <a:r>
              <a:rPr lang="en-US" sz="2800" smtClean="0">
                <a:latin typeface="Times New Roman" panose="02020603050405020304" charset="0"/>
                <a:cs typeface="Arial" panose="020B0604020202020204" pitchFamily="34" charset="0"/>
              </a:rPr>
              <a:t>5</a:t>
            </a:r>
            <a:endParaRPr lang="en-US" sz="2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5" name="标题 1"/>
          <p:cNvSpPr txBox="1"/>
          <p:nvPr/>
        </p:nvSpPr>
        <p:spPr>
          <a:xfrm rot="19800086">
            <a:off x="4265041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6-OHDA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6" name="标题 1"/>
          <p:cNvSpPr txBox="1"/>
          <p:nvPr/>
        </p:nvSpPr>
        <p:spPr>
          <a:xfrm rot="19800086">
            <a:off x="4749664" y="1429388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25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7" name="标题 1"/>
          <p:cNvSpPr txBox="1"/>
          <p:nvPr/>
        </p:nvSpPr>
        <p:spPr>
          <a:xfrm rot="19800086">
            <a:off x="5301086" y="1429387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5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8" name="标题 1"/>
          <p:cNvSpPr txBox="1"/>
          <p:nvPr/>
        </p:nvSpPr>
        <p:spPr>
          <a:xfrm rot="19800086">
            <a:off x="5878158" y="1429386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100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9" name="标题 1"/>
          <p:cNvSpPr txBox="1"/>
          <p:nvPr/>
        </p:nvSpPr>
        <p:spPr>
          <a:xfrm rot="19800086">
            <a:off x="3556787" y="1303799"/>
            <a:ext cx="3030245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control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sp>
        <p:nvSpPr>
          <p:cNvPr id="10" name="标题 1"/>
          <p:cNvSpPr txBox="1"/>
          <p:nvPr/>
        </p:nvSpPr>
        <p:spPr>
          <a:xfrm>
            <a:off x="5631338" y="629814"/>
            <a:ext cx="3351928" cy="466740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AS-IV(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 +6OHDA(100</a:t>
            </a:r>
            <a:r>
              <a:rPr lang="el-GR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 μ</a:t>
            </a:r>
            <a:r>
              <a:rPr lang="en-US" altLang="zh-CN" sz="1800" smtClean="0">
                <a:latin typeface="Times New Roman" panose="02020603050405020304" charset="0"/>
                <a:cs typeface="Arial" panose="020B0604020202020204" pitchFamily="34" charset="0"/>
              </a:rPr>
              <a:t>M)</a:t>
            </a:r>
            <a:endParaRPr lang="zh-CN" altLang="en-US" sz="1800">
              <a:latin typeface="Times New Roman" panose="02020603050405020304" charset="0"/>
              <a:cs typeface="Arial" panose="020B0604020202020204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255363" y="1162974"/>
            <a:ext cx="190726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3630838" y="3987357"/>
            <a:ext cx="93218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l"/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actin</a:t>
            </a:r>
          </a:p>
        </p:txBody>
      </p:sp>
      <p:sp>
        <p:nvSpPr>
          <p:cNvPr id="14" name="文本框 13"/>
          <p:cNvSpPr txBox="1"/>
          <p:nvPr/>
        </p:nvSpPr>
        <p:spPr>
          <a:xfrm>
            <a:off x="8150860" y="3987165"/>
            <a:ext cx="87503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en-US" b="1">
                <a:ea typeface="Times New Roman" panose="02020603050405020304" charset="0"/>
                <a:cs typeface="Times New Roman" panose="02020603050405020304" charset="0"/>
              </a:rPr>
              <a:t>42 kDa</a:t>
            </a:r>
          </a:p>
        </p:txBody>
      </p:sp>
      <p:sp>
        <p:nvSpPr>
          <p:cNvPr id="15" name="文本框 14"/>
          <p:cNvSpPr txBox="1"/>
          <p:nvPr/>
        </p:nvSpPr>
        <p:spPr>
          <a:xfrm>
            <a:off x="1327150" y="49530"/>
            <a:ext cx="10191115" cy="36830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zh-CN" altLang="en-US" b="1">
                <a:cs typeface="Times New Roman" panose="02020603050405020304" charset="0"/>
              </a:rPr>
              <a:t>The full uncropped an dunedited versions of the western blots in figure </a:t>
            </a:r>
            <a:r>
              <a:rPr lang="en-US" altLang="zh-CN" b="1">
                <a:cs typeface="Times New Roman" panose="02020603050405020304" charset="0"/>
              </a:rPr>
              <a:t>5</a:t>
            </a:r>
            <a:r>
              <a:rPr lang="zh-CN" altLang="en-US" b="1">
                <a:cs typeface="Times New Roman" panose="02020603050405020304" charset="0"/>
              </a:rPr>
              <a:t> with </a:t>
            </a:r>
            <a:r>
              <a:rPr lang="el-GR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β-</a:t>
            </a:r>
            <a:r>
              <a:rPr lang="en-US" altLang="zh-CN" b="1" smtClean="0">
                <a:latin typeface="Times New Roman" panose="02020603050405020304" charset="0"/>
                <a:cs typeface="Arial" panose="020B0604020202020204" pitchFamily="34" charset="0"/>
                <a:sym typeface="+mn-ea"/>
              </a:rPr>
              <a:t>actin</a:t>
            </a:r>
            <a:r>
              <a:rPr lang="zh-CN" altLang="en-US" b="1">
                <a:cs typeface="Times New Roman" panose="02020603050405020304" charset="0"/>
              </a:rPr>
              <a:t>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Times New Roman"/>
        <a:ea typeface=""/>
        <a:cs typeface=""/>
        <a:font script="Jpan" typeface="游ゴシック"/>
        <a:font script="Hang" typeface="맑은 고딕"/>
        <a:font script="Hans" typeface="Times New Roman"/>
        <a:font script="Hant" typeface="新細明體"/>
        <a:font script="Arab" typeface="Times New Roman"/>
        <a:font script="Hebr" typeface="Times New Roman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Times New Roman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Times New Roman"/>
        <a:font script="Hant" typeface="新細明體"/>
        <a:font script="Arab" typeface="Times New Roman"/>
        <a:font script="Hebr" typeface="Times New Roman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Times New Roman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Times New Roman"/>
        <a:font script="Hant" typeface="新細明體"/>
        <a:font script="Arab" typeface="Times New Roman"/>
        <a:font script="Hebr" typeface="Times New Roman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0</Words>
  <Application>Microsoft Office PowerPoint</Application>
  <PresentationFormat>自定义</PresentationFormat>
  <Paragraphs>120</Paragraphs>
  <Slides>1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4</vt:i4>
      </vt:variant>
    </vt:vector>
  </HeadingPairs>
  <TitlesOfParts>
    <vt:vector size="15" baseType="lpstr">
      <vt:lpstr>Office 主题​​</vt:lpstr>
      <vt:lpstr>Figure 4B</vt:lpstr>
      <vt:lpstr>Figure 4B </vt:lpstr>
      <vt:lpstr>Figure 4B </vt:lpstr>
      <vt:lpstr>Figure 5 </vt:lpstr>
      <vt:lpstr>Figure 5 </vt:lpstr>
      <vt:lpstr>Figure 5 </vt:lpstr>
      <vt:lpstr>Figure 5 </vt:lpstr>
      <vt:lpstr>Figure 5 </vt:lpstr>
      <vt:lpstr>Figure 5</vt:lpstr>
      <vt:lpstr>Figure 6A </vt:lpstr>
      <vt:lpstr>Figure 6A </vt:lpstr>
      <vt:lpstr>Figure 6A </vt:lpstr>
      <vt:lpstr>Figure 6A </vt:lpstr>
      <vt:lpstr>Figure 6A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4B Bax</dc:title>
  <dc:creator>Administrator</dc:creator>
  <cp:lastModifiedBy>ShawnC</cp:lastModifiedBy>
  <cp:revision>7</cp:revision>
  <dcterms:created xsi:type="dcterms:W3CDTF">2020-09-28T07:50:00Z</dcterms:created>
  <dcterms:modified xsi:type="dcterms:W3CDTF">2020-09-29T09:13:2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99</vt:lpwstr>
  </property>
</Properties>
</file>